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slides/slide1.xml" ContentType="application/vnd.openxmlformats-officedocument.presentationml.slide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theme/theme2.xml" ContentType="application/vnd.openxmlformats-officedocument.theme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app.xml" ContentType="application/vnd.openxmlformats-officedocument.extended-properties+xml"/>
  <Override PartName="/docProps/core.xml" ContentType="application/vnd.openxmlformats-package.core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7" r:id="rId2"/>
  </p:sldIdLst>
  <p:sldSz cx="6858000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DFF"/>
    <a:srgbClr val="0199FF"/>
    <a:srgbClr val="FF8C8C"/>
    <a:srgbClr val="22FC0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347"/>
    <p:restoredTop sz="96405"/>
  </p:normalViewPr>
  <p:slideViewPr>
    <p:cSldViewPr snapToGrid="0">
      <p:cViewPr>
        <p:scale>
          <a:sx n="275" d="100"/>
          <a:sy n="275" d="100"/>
        </p:scale>
        <p:origin x="100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28CA9A-5714-7344-9160-1BF3CFA06E3D}" type="datetimeFigureOut">
              <a:rPr lang="en-DE" smtClean="0"/>
              <a:t>30.10.22</a:t>
            </a:fld>
            <a:endParaRPr lang="en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75F609-9BC7-EF40-91CF-D70CAE59C7B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764638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1FCB18-F31C-4546-8BFA-73FC591CB01B}" type="slidenum">
              <a:rPr lang="en-DE" smtClean="0"/>
              <a:t>1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6181947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BCC9D-6995-E34E-B503-9E8C34DAFC8D}" type="datetimeFigureOut">
              <a:rPr lang="en-DE" smtClean="0"/>
              <a:t>30.10.22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38858-96A5-9547-8B35-716570E8C97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75470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BCC9D-6995-E34E-B503-9E8C34DAFC8D}" type="datetimeFigureOut">
              <a:rPr lang="en-DE" smtClean="0"/>
              <a:t>30.10.22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38858-96A5-9547-8B35-716570E8C97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63131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BCC9D-6995-E34E-B503-9E8C34DAFC8D}" type="datetimeFigureOut">
              <a:rPr lang="en-DE" smtClean="0"/>
              <a:t>30.10.22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38858-96A5-9547-8B35-716570E8C97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972986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BCC9D-6995-E34E-B503-9E8C34DAFC8D}" type="datetimeFigureOut">
              <a:rPr lang="en-DE" smtClean="0"/>
              <a:t>30.10.22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38858-96A5-9547-8B35-716570E8C97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61227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BCC9D-6995-E34E-B503-9E8C34DAFC8D}" type="datetimeFigureOut">
              <a:rPr lang="en-DE" smtClean="0"/>
              <a:t>30.10.22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38858-96A5-9547-8B35-716570E8C97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82910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BCC9D-6995-E34E-B503-9E8C34DAFC8D}" type="datetimeFigureOut">
              <a:rPr lang="en-DE" smtClean="0"/>
              <a:t>30.10.22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38858-96A5-9547-8B35-716570E8C97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861094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BCC9D-6995-E34E-B503-9E8C34DAFC8D}" type="datetimeFigureOut">
              <a:rPr lang="en-DE" smtClean="0"/>
              <a:t>30.10.22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38858-96A5-9547-8B35-716570E8C97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967951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BCC9D-6995-E34E-B503-9E8C34DAFC8D}" type="datetimeFigureOut">
              <a:rPr lang="en-DE" smtClean="0"/>
              <a:t>30.10.22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38858-96A5-9547-8B35-716570E8C97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784005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BCC9D-6995-E34E-B503-9E8C34DAFC8D}" type="datetimeFigureOut">
              <a:rPr lang="en-DE" smtClean="0"/>
              <a:t>30.10.22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38858-96A5-9547-8B35-716570E8C97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146080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BCC9D-6995-E34E-B503-9E8C34DAFC8D}" type="datetimeFigureOut">
              <a:rPr lang="en-DE" smtClean="0"/>
              <a:t>30.10.22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38858-96A5-9547-8B35-716570E8C97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499996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BCC9D-6995-E34E-B503-9E8C34DAFC8D}" type="datetimeFigureOut">
              <a:rPr lang="en-DE" smtClean="0"/>
              <a:t>30.10.22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38858-96A5-9547-8B35-716570E8C97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00184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BCC9D-6995-E34E-B503-9E8C34DAFC8D}" type="datetimeFigureOut">
              <a:rPr lang="en-DE" smtClean="0"/>
              <a:t>30.10.22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538858-96A5-9547-8B35-716570E8C97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295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F04A4AFB-885A-7C49-30B3-35C00DC0CC2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851" y="432565"/>
            <a:ext cx="6336161" cy="4231837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A985889-15BE-B357-6A43-2C40464888F8}"/>
              </a:ext>
            </a:extLst>
          </p:cNvPr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851" y="5084412"/>
            <a:ext cx="6337016" cy="4230679"/>
          </a:xfrm>
          <a:prstGeom prst="rect">
            <a:avLst/>
          </a:prstGeom>
        </p:spPr>
      </p:pic>
      <p:sp>
        <p:nvSpPr>
          <p:cNvPr id="20" name="Google Shape;97;p1">
            <a:extLst>
              <a:ext uri="{FF2B5EF4-FFF2-40B4-BE49-F238E27FC236}">
                <a16:creationId xmlns:a16="http://schemas.microsoft.com/office/drawing/2014/main" id="{92F3AA18-A379-EA92-1B36-55C7DCBE22A4}"/>
              </a:ext>
            </a:extLst>
          </p:cNvPr>
          <p:cNvSpPr/>
          <p:nvPr/>
        </p:nvSpPr>
        <p:spPr>
          <a:xfrm>
            <a:off x="105752" y="153472"/>
            <a:ext cx="470775" cy="7395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390" tIns="46182" rIns="92390" bIns="46182" anchor="t" anchorCtr="0">
            <a:spAutoFit/>
          </a:bodyPr>
          <a:lstStyle/>
          <a:p>
            <a:r>
              <a:rPr lang="tr-TR" sz="1400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sz="1400" b="1" dirty="0">
              <a:solidFill>
                <a:schemeClr val="dk1"/>
              </a:solidFill>
              <a:latin typeface="Arial" panose="020B0604020202020204" pitchFamily="34" charset="0"/>
              <a:ea typeface="Arial"/>
              <a:cs typeface="Arial" panose="020B0604020202020204" pitchFamily="34" charset="0"/>
              <a:sym typeface="Arial"/>
            </a:endParaRPr>
          </a:p>
          <a:p>
            <a:br>
              <a:rPr lang="de-DE" sz="1400" b="1" dirty="0">
                <a:solidFill>
                  <a:schemeClr val="dk1"/>
                </a:solidFill>
                <a:latin typeface="Arial" panose="020B0604020202020204" pitchFamily="34" charset="0"/>
                <a:ea typeface="Arial"/>
                <a:cs typeface="Arial" panose="020B0604020202020204" pitchFamily="34" charset="0"/>
                <a:sym typeface="Arial"/>
              </a:rPr>
            </a:br>
            <a:endParaRPr sz="1400" b="1" dirty="0">
              <a:solidFill>
                <a:schemeClr val="dk1"/>
              </a:solidFill>
              <a:latin typeface="Arial" panose="020B0604020202020204" pitchFamily="34" charset="0"/>
              <a:ea typeface="Arial"/>
              <a:cs typeface="Arial" panose="020B0604020202020204" pitchFamily="34" charset="0"/>
              <a:sym typeface="Arial"/>
            </a:endParaRPr>
          </a:p>
        </p:txBody>
      </p:sp>
      <p:sp>
        <p:nvSpPr>
          <p:cNvPr id="21" name="Google Shape;97;p1">
            <a:extLst>
              <a:ext uri="{FF2B5EF4-FFF2-40B4-BE49-F238E27FC236}">
                <a16:creationId xmlns:a16="http://schemas.microsoft.com/office/drawing/2014/main" id="{602BF3F1-2080-B50F-D67B-394DDA62C243}"/>
              </a:ext>
            </a:extLst>
          </p:cNvPr>
          <p:cNvSpPr/>
          <p:nvPr/>
        </p:nvSpPr>
        <p:spPr>
          <a:xfrm>
            <a:off x="105752" y="4716406"/>
            <a:ext cx="470775" cy="7395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2390" tIns="46182" rIns="92390" bIns="46182" anchor="t" anchorCtr="0">
            <a:spAutoFit/>
          </a:bodyPr>
          <a:lstStyle/>
          <a:p>
            <a:r>
              <a:rPr lang="tr-TR" sz="1400" b="1" dirty="0">
                <a:solidFill>
                  <a:schemeClr val="dk1"/>
                </a:solidFill>
                <a:latin typeface="Arial" panose="020B0604020202020204" pitchFamily="34" charset="0"/>
                <a:ea typeface="Arial"/>
                <a:cs typeface="Arial" panose="020B0604020202020204" pitchFamily="34" charset="0"/>
                <a:sym typeface="Arial"/>
              </a:rPr>
              <a:t>B</a:t>
            </a:r>
            <a:endParaRPr sz="1400" b="1" dirty="0">
              <a:solidFill>
                <a:schemeClr val="dk1"/>
              </a:solidFill>
              <a:latin typeface="Arial" panose="020B0604020202020204" pitchFamily="34" charset="0"/>
              <a:ea typeface="Arial"/>
              <a:cs typeface="Arial" panose="020B0604020202020204" pitchFamily="34" charset="0"/>
              <a:sym typeface="Arial"/>
            </a:endParaRPr>
          </a:p>
          <a:p>
            <a:br>
              <a:rPr lang="de-DE" sz="1400" b="1" dirty="0">
                <a:solidFill>
                  <a:schemeClr val="dk1"/>
                </a:solidFill>
                <a:latin typeface="Arial" panose="020B0604020202020204" pitchFamily="34" charset="0"/>
                <a:ea typeface="Arial"/>
                <a:cs typeface="Arial" panose="020B0604020202020204" pitchFamily="34" charset="0"/>
                <a:sym typeface="Arial"/>
              </a:rPr>
            </a:br>
            <a:endParaRPr sz="1400" b="1" dirty="0">
              <a:solidFill>
                <a:schemeClr val="dk1"/>
              </a:solidFill>
              <a:latin typeface="Arial" panose="020B0604020202020204" pitchFamily="34" charset="0"/>
              <a:ea typeface="Arial"/>
              <a:cs typeface="Arial" panose="020B0604020202020204" pitchFamily="34" charset="0"/>
              <a:sym typeface="Arial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4E3A183C-1340-A36F-E6DF-D49E62F2568C}"/>
              </a:ext>
            </a:extLst>
          </p:cNvPr>
          <p:cNvGrpSpPr/>
          <p:nvPr/>
        </p:nvGrpSpPr>
        <p:grpSpPr>
          <a:xfrm>
            <a:off x="400164" y="9403066"/>
            <a:ext cx="1395659" cy="172564"/>
            <a:chOff x="400164" y="9403066"/>
            <a:chExt cx="1395659" cy="172564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BA405223-E121-D238-1E2E-E285CC715DA5}"/>
                </a:ext>
              </a:extLst>
            </p:cNvPr>
            <p:cNvGrpSpPr/>
            <p:nvPr/>
          </p:nvGrpSpPr>
          <p:grpSpPr>
            <a:xfrm>
              <a:off x="400164" y="9406353"/>
              <a:ext cx="339478" cy="169277"/>
              <a:chOff x="747399" y="9484472"/>
              <a:chExt cx="339478" cy="169277"/>
            </a:xfrm>
          </p:grpSpPr>
          <p:sp>
            <p:nvSpPr>
              <p:cNvPr id="5" name="Rectangle 4">
                <a:extLst>
                  <a:ext uri="{FF2B5EF4-FFF2-40B4-BE49-F238E27FC236}">
                    <a16:creationId xmlns:a16="http://schemas.microsoft.com/office/drawing/2014/main" id="{5870F748-9F75-9E00-76BB-17B859B38BDE}"/>
                  </a:ext>
                </a:extLst>
              </p:cNvPr>
              <p:cNvSpPr/>
              <p:nvPr/>
            </p:nvSpPr>
            <p:spPr>
              <a:xfrm flipV="1">
                <a:off x="804892" y="9515055"/>
                <a:ext cx="224493" cy="101538"/>
              </a:xfrm>
              <a:prstGeom prst="rect">
                <a:avLst/>
              </a:prstGeom>
              <a:solidFill>
                <a:srgbClr val="22FC0D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DE" dirty="0"/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D52AD917-3DF3-AA7C-3B25-24A20F206FD5}"/>
                  </a:ext>
                </a:extLst>
              </p:cNvPr>
              <p:cNvSpPr txBox="1"/>
              <p:nvPr/>
            </p:nvSpPr>
            <p:spPr>
              <a:xfrm>
                <a:off x="747399" y="9484472"/>
                <a:ext cx="33947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DE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</a:p>
            </p:txBody>
          </p: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7301DB3-C90E-3D59-BCFB-E7997EFB2D8E}"/>
                </a:ext>
              </a:extLst>
            </p:cNvPr>
            <p:cNvSpPr txBox="1"/>
            <p:nvPr/>
          </p:nvSpPr>
          <p:spPr>
            <a:xfrm>
              <a:off x="636531" y="9403066"/>
              <a:ext cx="115929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 n</a:t>
              </a:r>
              <a:r>
                <a:rPr lang="en-DE" sz="500" dirty="0">
                  <a:latin typeface="Arial" panose="020B0604020202020204" pitchFamily="34" charset="0"/>
                  <a:cs typeface="Arial" panose="020B0604020202020204" pitchFamily="34" charset="0"/>
                </a:rPr>
                <a:t>ot regulated in both comparisons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C840FC88-A910-D8A6-426A-0096AA19323D}"/>
              </a:ext>
            </a:extLst>
          </p:cNvPr>
          <p:cNvGrpSpPr/>
          <p:nvPr/>
        </p:nvGrpSpPr>
        <p:grpSpPr>
          <a:xfrm>
            <a:off x="400164" y="9623474"/>
            <a:ext cx="1739199" cy="246221"/>
            <a:chOff x="400164" y="9623474"/>
            <a:chExt cx="1739199" cy="246221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1240385E-CF03-F26C-A107-38005315A678}"/>
                </a:ext>
              </a:extLst>
            </p:cNvPr>
            <p:cNvGrpSpPr/>
            <p:nvPr/>
          </p:nvGrpSpPr>
          <p:grpSpPr>
            <a:xfrm>
              <a:off x="400164" y="9661947"/>
              <a:ext cx="339478" cy="169277"/>
              <a:chOff x="896149" y="9633585"/>
              <a:chExt cx="339478" cy="169277"/>
            </a:xfrm>
          </p:grpSpPr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857541B2-06B7-0E04-555C-BC4D45F4D580}"/>
                  </a:ext>
                </a:extLst>
              </p:cNvPr>
              <p:cNvSpPr/>
              <p:nvPr/>
            </p:nvSpPr>
            <p:spPr>
              <a:xfrm flipV="1">
                <a:off x="957292" y="9667455"/>
                <a:ext cx="224493" cy="101538"/>
              </a:xfrm>
              <a:prstGeom prst="rect">
                <a:avLst/>
              </a:prstGeom>
              <a:solidFill>
                <a:srgbClr val="FF8C8C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DE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B9FA297-499F-6404-D48A-A2F3C384256B}"/>
                  </a:ext>
                </a:extLst>
              </p:cNvPr>
              <p:cNvSpPr txBox="1"/>
              <p:nvPr/>
            </p:nvSpPr>
            <p:spPr>
              <a:xfrm>
                <a:off x="896149" y="9633585"/>
                <a:ext cx="33947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DE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</a:p>
            </p:txBody>
          </p: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355206D-E265-DE67-8ACD-A2EB01FAF201}"/>
                </a:ext>
              </a:extLst>
            </p:cNvPr>
            <p:cNvSpPr txBox="1"/>
            <p:nvPr/>
          </p:nvSpPr>
          <p:spPr>
            <a:xfrm>
              <a:off x="651455" y="9623474"/>
              <a:ext cx="14879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tr-TR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upregulated</a:t>
              </a:r>
              <a:r>
                <a:rPr lang="tr-TR" sz="500" dirty="0">
                  <a:latin typeface="Arial" panose="020B0604020202020204" pitchFamily="34" charset="0"/>
                  <a:cs typeface="Arial" panose="020B0604020202020204" pitchFamily="34" charset="0"/>
                </a:rPr>
                <a:t> in OGD-VEH vs. CONTROL-VEH</a:t>
              </a:r>
            </a:p>
            <a:p>
              <a:r>
                <a:rPr lang="tr-TR" sz="500" dirty="0">
                  <a:latin typeface="Arial" panose="020B0604020202020204" pitchFamily="34" charset="0"/>
                  <a:cs typeface="Arial" panose="020B0604020202020204" pitchFamily="34" charset="0"/>
                </a:rPr>
                <a:t>not </a:t>
              </a:r>
              <a:r>
                <a:rPr lang="tr-TR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ed</a:t>
              </a:r>
              <a:r>
                <a:rPr lang="tr-TR" sz="500" dirty="0">
                  <a:latin typeface="Arial" panose="020B0604020202020204" pitchFamily="34" charset="0"/>
                  <a:cs typeface="Arial" panose="020B0604020202020204" pitchFamily="34" charset="0"/>
                </a:rPr>
                <a:t> in OGD-TIA vs. CONTROL-TIA</a:t>
              </a:r>
              <a:endParaRPr lang="en-DE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997BD5D3-B543-D8E3-2036-CCBCB94E657B}"/>
              </a:ext>
            </a:extLst>
          </p:cNvPr>
          <p:cNvGrpSpPr/>
          <p:nvPr/>
        </p:nvGrpSpPr>
        <p:grpSpPr>
          <a:xfrm>
            <a:off x="2089797" y="9396851"/>
            <a:ext cx="1367698" cy="174394"/>
            <a:chOff x="2089797" y="9396851"/>
            <a:chExt cx="1367698" cy="174394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5009108F-DCD0-621D-A7EB-5736D02182FF}"/>
                </a:ext>
              </a:extLst>
            </p:cNvPr>
            <p:cNvGrpSpPr/>
            <p:nvPr/>
          </p:nvGrpSpPr>
          <p:grpSpPr>
            <a:xfrm>
              <a:off x="2089797" y="9401968"/>
              <a:ext cx="339478" cy="169277"/>
              <a:chOff x="1457382" y="9598458"/>
              <a:chExt cx="339478" cy="169277"/>
            </a:xfrm>
          </p:grpSpPr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C2FFA0F3-B08D-74DA-4099-08611EB2F238}"/>
                  </a:ext>
                </a:extLst>
              </p:cNvPr>
              <p:cNvSpPr/>
              <p:nvPr/>
            </p:nvSpPr>
            <p:spPr>
              <a:xfrm flipV="1">
                <a:off x="1514875" y="9633563"/>
                <a:ext cx="224493" cy="101538"/>
              </a:xfrm>
              <a:prstGeom prst="rect">
                <a:avLst/>
              </a:prstGeom>
              <a:solidFill>
                <a:srgbClr val="FF8C8C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DE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D00B20B7-F995-DD0F-B53C-8C19FC936649}"/>
                  </a:ext>
                </a:extLst>
              </p:cNvPr>
              <p:cNvSpPr txBox="1"/>
              <p:nvPr/>
            </p:nvSpPr>
            <p:spPr>
              <a:xfrm>
                <a:off x="1457382" y="9598458"/>
                <a:ext cx="33947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DE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032C4A3-4E0D-8505-8BC7-07CFF8E0D966}"/>
                </a:ext>
              </a:extLst>
            </p:cNvPr>
            <p:cNvSpPr txBox="1"/>
            <p:nvPr/>
          </p:nvSpPr>
          <p:spPr>
            <a:xfrm>
              <a:off x="2351102" y="9396851"/>
              <a:ext cx="1106393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upr</a:t>
              </a:r>
              <a:r>
                <a:rPr lang="en-DE" sz="500" dirty="0">
                  <a:latin typeface="Arial" panose="020B0604020202020204" pitchFamily="34" charset="0"/>
                  <a:cs typeface="Arial" panose="020B0604020202020204" pitchFamily="34" charset="0"/>
                </a:rPr>
                <a:t>egulated in both comparisons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A417152A-E8BC-6C67-1F29-1065CC9B6F72}"/>
              </a:ext>
            </a:extLst>
          </p:cNvPr>
          <p:cNvGrpSpPr/>
          <p:nvPr/>
        </p:nvGrpSpPr>
        <p:grpSpPr>
          <a:xfrm>
            <a:off x="2089797" y="9623474"/>
            <a:ext cx="1820374" cy="246221"/>
            <a:chOff x="2089797" y="9623474"/>
            <a:chExt cx="1820374" cy="246221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B1EB1C3C-5DCF-5B14-3B0F-D0D3C8A89E17}"/>
                </a:ext>
              </a:extLst>
            </p:cNvPr>
            <p:cNvGrpSpPr/>
            <p:nvPr/>
          </p:nvGrpSpPr>
          <p:grpSpPr>
            <a:xfrm>
              <a:off x="2089797" y="9659303"/>
              <a:ext cx="339478" cy="169277"/>
              <a:chOff x="2089797" y="9634242"/>
              <a:chExt cx="339478" cy="169277"/>
            </a:xfrm>
          </p:grpSpPr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CD98B730-225A-8D58-C977-DAEFC704F893}"/>
                  </a:ext>
                </a:extLst>
              </p:cNvPr>
              <p:cNvSpPr/>
              <p:nvPr/>
            </p:nvSpPr>
            <p:spPr>
              <a:xfrm flipV="1">
                <a:off x="2147290" y="9668113"/>
                <a:ext cx="224493" cy="101538"/>
              </a:xfrm>
              <a:prstGeom prst="rect">
                <a:avLst/>
              </a:prstGeom>
              <a:solidFill>
                <a:srgbClr val="00BDFF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DE" dirty="0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F0FDF38C-9BBE-7BE5-907A-F2F3F2614656}"/>
                  </a:ext>
                </a:extLst>
              </p:cNvPr>
              <p:cNvSpPr txBox="1"/>
              <p:nvPr/>
            </p:nvSpPr>
            <p:spPr>
              <a:xfrm>
                <a:off x="2089797" y="9634242"/>
                <a:ext cx="33947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DE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</a:p>
            </p:txBody>
          </p: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1C2A7D3-C7CE-1A2C-7CD4-E405EAD77D48}"/>
                </a:ext>
              </a:extLst>
            </p:cNvPr>
            <p:cNvSpPr txBox="1"/>
            <p:nvPr/>
          </p:nvSpPr>
          <p:spPr>
            <a:xfrm>
              <a:off x="2340511" y="9623474"/>
              <a:ext cx="15696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tr-TR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downregulated</a:t>
              </a:r>
              <a:r>
                <a:rPr lang="tr-TR" sz="500" dirty="0">
                  <a:latin typeface="Arial" panose="020B0604020202020204" pitchFamily="34" charset="0"/>
                  <a:cs typeface="Arial" panose="020B0604020202020204" pitchFamily="34" charset="0"/>
                </a:rPr>
                <a:t> in OGD-VEH vs. CONTROL-VEH</a:t>
              </a:r>
            </a:p>
            <a:p>
              <a:r>
                <a:rPr lang="tr-TR" sz="500" dirty="0">
                  <a:latin typeface="Arial" panose="020B0604020202020204" pitchFamily="34" charset="0"/>
                  <a:cs typeface="Arial" panose="020B0604020202020204" pitchFamily="34" charset="0"/>
                </a:rPr>
                <a:t>not </a:t>
              </a:r>
              <a:r>
                <a:rPr lang="tr-TR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regulated</a:t>
              </a:r>
              <a:r>
                <a:rPr lang="tr-TR" sz="500" dirty="0">
                  <a:latin typeface="Arial" panose="020B0604020202020204" pitchFamily="34" charset="0"/>
                  <a:cs typeface="Arial" panose="020B0604020202020204" pitchFamily="34" charset="0"/>
                </a:rPr>
                <a:t> in OGD-TIA vs. CONTROL-TIA</a:t>
              </a:r>
              <a:endParaRPr lang="en-DE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D8218E6F-0DC6-567D-6C2A-14F76CD4DB24}"/>
              </a:ext>
            </a:extLst>
          </p:cNvPr>
          <p:cNvGrpSpPr/>
          <p:nvPr/>
        </p:nvGrpSpPr>
        <p:grpSpPr>
          <a:xfrm>
            <a:off x="3852678" y="9396851"/>
            <a:ext cx="1430434" cy="175491"/>
            <a:chOff x="3852678" y="9396851"/>
            <a:chExt cx="1430434" cy="175491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4F8D233A-BA50-C2E9-25A7-C65234A98177}"/>
                </a:ext>
              </a:extLst>
            </p:cNvPr>
            <p:cNvGrpSpPr/>
            <p:nvPr/>
          </p:nvGrpSpPr>
          <p:grpSpPr>
            <a:xfrm>
              <a:off x="3852678" y="9403065"/>
              <a:ext cx="339478" cy="169277"/>
              <a:chOff x="2130862" y="9582816"/>
              <a:chExt cx="339478" cy="169277"/>
            </a:xfrm>
          </p:grpSpPr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67E416FB-2EC0-3027-118C-6C60C58E4519}"/>
                  </a:ext>
                </a:extLst>
              </p:cNvPr>
              <p:cNvSpPr/>
              <p:nvPr/>
            </p:nvSpPr>
            <p:spPr>
              <a:xfrm flipV="1">
                <a:off x="2188355" y="9616686"/>
                <a:ext cx="224493" cy="101538"/>
              </a:xfrm>
              <a:prstGeom prst="rect">
                <a:avLst/>
              </a:prstGeom>
              <a:solidFill>
                <a:srgbClr val="0199FF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DE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E7BFEC0-97BD-C50C-B3FB-77BC713FD10F}"/>
                  </a:ext>
                </a:extLst>
              </p:cNvPr>
              <p:cNvSpPr txBox="1"/>
              <p:nvPr/>
            </p:nvSpPr>
            <p:spPr>
              <a:xfrm>
                <a:off x="2130862" y="9582816"/>
                <a:ext cx="33947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DE" sz="5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ene</a:t>
                </a:r>
              </a:p>
            </p:txBody>
          </p:sp>
        </p:grp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E8EC0B2-B414-753A-9F59-5B26668EEF57}"/>
                </a:ext>
              </a:extLst>
            </p:cNvPr>
            <p:cNvSpPr txBox="1"/>
            <p:nvPr/>
          </p:nvSpPr>
          <p:spPr>
            <a:xfrm>
              <a:off x="4094966" y="9396851"/>
              <a:ext cx="118814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500" dirty="0" err="1">
                  <a:latin typeface="Arial" panose="020B0604020202020204" pitchFamily="34" charset="0"/>
                  <a:cs typeface="Arial" panose="020B0604020202020204" pitchFamily="34" charset="0"/>
                </a:rPr>
                <a:t>downr</a:t>
              </a:r>
              <a:r>
                <a:rPr lang="en-DE" sz="500" dirty="0">
                  <a:latin typeface="Arial" panose="020B0604020202020204" pitchFamily="34" charset="0"/>
                  <a:cs typeface="Arial" panose="020B0604020202020204" pitchFamily="34" charset="0"/>
                </a:rPr>
                <a:t>egulated in both comparison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582813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5165F878284174A9DAF41EBDC0CBE38" ma:contentTypeVersion="2" ma:contentTypeDescription="Create a new document." ma:contentTypeScope="" ma:versionID="1446cd1cca9ede4fdbb9d37d602b2df2">
  <xsd:schema xmlns:xsd="http://www.w3.org/2001/XMLSchema" xmlns:xs="http://www.w3.org/2001/XMLSchema" xmlns:p="http://schemas.microsoft.com/office/2006/metadata/properties" xmlns:ns2="c81dfc03-3b2f-4c41-8a9e-27c996741e2b" targetNamespace="http://schemas.microsoft.com/office/2006/metadata/properties" ma:root="true" ma:fieldsID="d9152f2d55eaecba5bad4de7b1335980" ns2:_="">
    <xsd:import namespace="c81dfc03-3b2f-4c41-8a9e-27c996741e2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81dfc03-3b2f-4c41-8a9e-27c996741e2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7598B803-7E9D-4A8A-A9FE-A267D7BB7803}"/>
</file>

<file path=customXml/itemProps2.xml><?xml version="1.0" encoding="utf-8"?>
<ds:datastoreItem xmlns:ds="http://schemas.openxmlformats.org/officeDocument/2006/customXml" ds:itemID="{9E8E2BBC-341A-4588-A0A2-B39AB0EA13F1}"/>
</file>

<file path=customXml/itemProps3.xml><?xml version="1.0" encoding="utf-8"?>
<ds:datastoreItem xmlns:ds="http://schemas.openxmlformats.org/officeDocument/2006/customXml" ds:itemID="{CA83D2E0-FDFB-4D17-B29E-21C1B860183F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8</TotalTime>
  <Words>53</Words>
  <Application>Microsoft Macintosh PowerPoint</Application>
  <PresentationFormat>Custom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5</cp:revision>
  <dcterms:created xsi:type="dcterms:W3CDTF">2022-10-11T13:29:48Z</dcterms:created>
  <dcterms:modified xsi:type="dcterms:W3CDTF">2022-10-30T19:19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5165F878284174A9DAF41EBDC0CBE38</vt:lpwstr>
  </property>
</Properties>
</file>